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852" y="3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347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7701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9634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5081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0735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5359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08748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9599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715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8447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623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2FD16-4EEB-4DDE-A4D6-59C9646755A3}" type="datetimeFigureOut">
              <a:rPr lang="zh-CN" altLang="en-US" smtClean="0"/>
              <a:t>2020/4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22CF5-A93D-4472-9245-A6594CF9F8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30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2305050" y="470559"/>
            <a:ext cx="7419975" cy="654459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40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SARS-</a:t>
            </a:r>
            <a:r>
              <a:rPr lang="en-US" dirty="0" err="1" smtClean="0"/>
              <a:t>CoV</a:t>
            </a:r>
            <a:r>
              <a:rPr lang="en-US" dirty="0" smtClean="0"/>
              <a:t> spike protein</a:t>
            </a:r>
          </a:p>
          <a:p>
            <a:r>
              <a:rPr lang="en-US" dirty="0" smtClean="0"/>
              <a:t>Residues within 6</a:t>
            </a:r>
            <a:r>
              <a:rPr lang="en-US" altLang="zh-CN" dirty="0" smtClean="0"/>
              <a:t>Å around hACE2</a:t>
            </a:r>
            <a:endParaRPr 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7981529" y="1713103"/>
            <a:ext cx="23965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/>
              <a:t>Residues 6Å around hACE2</a:t>
            </a:r>
            <a:endParaRPr lang="zh-CN" altLang="en-US" sz="1600" dirty="0"/>
          </a:p>
        </p:txBody>
      </p:sp>
      <p:grpSp>
        <p:nvGrpSpPr>
          <p:cNvPr id="6" name="组合 5"/>
          <p:cNvGrpSpPr/>
          <p:nvPr/>
        </p:nvGrpSpPr>
        <p:grpSpPr>
          <a:xfrm>
            <a:off x="1103870" y="1452933"/>
            <a:ext cx="6046573" cy="5224092"/>
            <a:chOff x="1672281" y="1030769"/>
            <a:chExt cx="6046573" cy="5224092"/>
          </a:xfrm>
        </p:grpSpPr>
        <p:sp>
          <p:nvSpPr>
            <p:cNvPr id="7" name="矩形 6"/>
            <p:cNvSpPr/>
            <p:nvPr/>
          </p:nvSpPr>
          <p:spPr>
            <a:xfrm>
              <a:off x="4134066" y="1030769"/>
              <a:ext cx="112300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 smtClean="0">
                  <a:solidFill>
                    <a:srgbClr val="21B9B9"/>
                  </a:solidFill>
                </a:rPr>
                <a:t>Spike RBD</a:t>
              </a:r>
              <a:endParaRPr lang="zh-CN" altLang="en-US" dirty="0">
                <a:solidFill>
                  <a:srgbClr val="21B9B9"/>
                </a:solidFill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4300298" y="5885529"/>
              <a:ext cx="79053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 smtClean="0">
                  <a:solidFill>
                    <a:srgbClr val="687D68"/>
                  </a:solidFill>
                </a:rPr>
                <a:t>hACE2</a:t>
              </a:r>
              <a:endParaRPr lang="zh-CN" altLang="en-US" dirty="0">
                <a:solidFill>
                  <a:srgbClr val="687D68"/>
                </a:solidFill>
              </a:endParaRPr>
            </a:p>
          </p:txBody>
        </p:sp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37" t="3829" r="18528" b="4655"/>
            <a:stretch/>
          </p:blipFill>
          <p:spPr>
            <a:xfrm>
              <a:off x="1672281" y="1401472"/>
              <a:ext cx="6046573" cy="4484057"/>
            </a:xfrm>
            <a:prstGeom prst="rect">
              <a:avLst/>
            </a:prstGeom>
          </p:spPr>
        </p:pic>
        <p:sp>
          <p:nvSpPr>
            <p:cNvPr id="10" name="矩形 9"/>
            <p:cNvSpPr/>
            <p:nvPr/>
          </p:nvSpPr>
          <p:spPr>
            <a:xfrm>
              <a:off x="6771159" y="5639512"/>
              <a:ext cx="94769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 smtClean="0"/>
                <a:t>PDB: 6CS2</a:t>
              </a:r>
              <a:endParaRPr lang="zh-CN" altLang="en-US" sz="1400" b="1" dirty="0"/>
            </a:p>
          </p:txBody>
        </p:sp>
      </p:grpSp>
      <p:graphicFrame>
        <p:nvGraphicFramePr>
          <p:cNvPr id="11" name="表格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849125"/>
              </p:ext>
            </p:extLst>
          </p:nvPr>
        </p:nvGraphicFramePr>
        <p:xfrm>
          <a:off x="8160171" y="2051657"/>
          <a:ext cx="2039240" cy="421904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19620"/>
                <a:gridCol w="1019620"/>
              </a:tblGrid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K3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4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4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4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4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4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4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4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4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D4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4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4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4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G4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4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F4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4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Y48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F4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4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4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4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D4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4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G4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G4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4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I4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A4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4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4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Q4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81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47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79847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1872224"/>
              </p:ext>
            </p:extLst>
          </p:nvPr>
        </p:nvGraphicFramePr>
        <p:xfrm>
          <a:off x="8153400" y="1331402"/>
          <a:ext cx="2052782" cy="474692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6391"/>
                <a:gridCol w="1026391"/>
              </a:tblGrid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S45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V5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4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5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4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5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D4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5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4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5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A4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D5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G4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G5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4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D5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Q4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5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4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Y5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5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5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K5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5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5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5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5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V5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5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A5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D5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5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5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G5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5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5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983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E5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A5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8021782" y="992848"/>
            <a:ext cx="23160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/>
              <a:t>Residues 6Å around DPP4</a:t>
            </a:r>
            <a:endParaRPr lang="zh-CN" altLang="en-US" sz="1600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12" r="14753" b="-40"/>
          <a:stretch/>
        </p:blipFill>
        <p:spPr>
          <a:xfrm>
            <a:off x="1246908" y="1401472"/>
            <a:ext cx="6096740" cy="4606781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4837099" y="1032140"/>
            <a:ext cx="6773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solidFill>
                  <a:srgbClr val="21B9B9"/>
                </a:solidFill>
              </a:rPr>
              <a:t>Spike</a:t>
            </a:r>
            <a:endParaRPr lang="zh-CN" altLang="en-US" dirty="0">
              <a:solidFill>
                <a:srgbClr val="21B9B9"/>
              </a:solidFill>
            </a:endParaRPr>
          </a:p>
        </p:txBody>
      </p:sp>
      <p:sp>
        <p:nvSpPr>
          <p:cNvPr id="9" name="矩形 8"/>
          <p:cNvSpPr/>
          <p:nvPr/>
        </p:nvSpPr>
        <p:spPr>
          <a:xfrm>
            <a:off x="3954479" y="6009050"/>
            <a:ext cx="681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solidFill>
                  <a:srgbClr val="687D68"/>
                </a:solidFill>
              </a:rPr>
              <a:t>DPP4</a:t>
            </a:r>
            <a:endParaRPr lang="zh-CN" altLang="en-US" dirty="0">
              <a:solidFill>
                <a:srgbClr val="687D68"/>
              </a:solidFill>
            </a:endParaRPr>
          </a:p>
        </p:txBody>
      </p:sp>
      <p:sp>
        <p:nvSpPr>
          <p:cNvPr id="11" name="Title 1"/>
          <p:cNvSpPr txBox="1">
            <a:spLocks/>
          </p:cNvSpPr>
          <p:nvPr/>
        </p:nvSpPr>
        <p:spPr>
          <a:xfrm>
            <a:off x="2371725" y="337592"/>
            <a:ext cx="7419975" cy="654459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40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MERS-</a:t>
            </a:r>
            <a:r>
              <a:rPr lang="en-US" dirty="0" err="1" smtClean="0"/>
              <a:t>CoV</a:t>
            </a:r>
            <a:r>
              <a:rPr lang="en-US" dirty="0" smtClean="0"/>
              <a:t> spike protein</a:t>
            </a:r>
          </a:p>
          <a:p>
            <a:r>
              <a:rPr lang="en-US" dirty="0" smtClean="0"/>
              <a:t>Residues within 6</a:t>
            </a:r>
            <a:r>
              <a:rPr lang="en-US" altLang="zh-CN" dirty="0" smtClean="0"/>
              <a:t>Å around hDPP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8289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3</Words>
  <Application>Microsoft Office PowerPoint</Application>
  <PresentationFormat>宽屏</PresentationFormat>
  <Paragraphs>8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You</dc:creator>
  <cp:lastModifiedBy>LiYou</cp:lastModifiedBy>
  <cp:revision>2</cp:revision>
  <dcterms:created xsi:type="dcterms:W3CDTF">2020-04-13T15:14:19Z</dcterms:created>
  <dcterms:modified xsi:type="dcterms:W3CDTF">2020-04-13T15:16:29Z</dcterms:modified>
</cp:coreProperties>
</file>